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notesMasterIdLst>
    <p:notesMasterId r:id="rId6"/>
  </p:notesMasterIdLst>
  <p:sldIdLst>
    <p:sldId id="271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D6BFA2E-F172-2556-00E4-1D2C5CEC1308}" name="Sara Wienke" initials="SW" userId="S::swienke@guardanthealth.com::44f54943-3314-470e-928b-597200c85ffe" providerId="AD"/>
  <p188:author id="{1241055D-7DF1-DB9D-7BCF-C5A38B4AA1EF}" name="Jude Masannat" initials="JM" userId="S::jmasannat@guardanthealth.com::48affbf4-8ab1-4fc4-82db-3208965ad05e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868"/>
    <p:restoredTop sz="94558"/>
  </p:normalViewPr>
  <p:slideViewPr>
    <p:cSldViewPr snapToGrid="0">
      <p:cViewPr>
        <p:scale>
          <a:sx n="130" d="100"/>
          <a:sy n="130" d="100"/>
        </p:scale>
        <p:origin x="2448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8/10/relationships/authors" Target="authors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313F00-949A-7A41-BA11-E8DECFFB2187}" type="datetimeFigureOut">
              <a:rPr lang="en-US" smtClean="0"/>
              <a:t>7/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333865-40B2-6249-89FB-0719449F8D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73972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12953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55544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14251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36965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7388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9285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1562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42827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32700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5718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331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1653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E683156-C6F9-BC25-1806-BA553E04F16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5D357BBC-2AB5-8535-7065-7D7FECBA258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2396994"/>
              </p:ext>
            </p:extLst>
          </p:nvPr>
        </p:nvGraphicFramePr>
        <p:xfrm>
          <a:off x="471487" y="944503"/>
          <a:ext cx="5442156" cy="388938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933802">
                  <a:extLst>
                    <a:ext uri="{9D8B030D-6E8A-4147-A177-3AD203B41FA5}">
                      <a16:colId xmlns:a16="http://schemas.microsoft.com/office/drawing/2014/main" val="1354439423"/>
                    </a:ext>
                  </a:extLst>
                </a:gridCol>
                <a:gridCol w="570534">
                  <a:extLst>
                    <a:ext uri="{9D8B030D-6E8A-4147-A177-3AD203B41FA5}">
                      <a16:colId xmlns:a16="http://schemas.microsoft.com/office/drawing/2014/main" val="2242456941"/>
                    </a:ext>
                  </a:extLst>
                </a:gridCol>
                <a:gridCol w="1005884">
                  <a:extLst>
                    <a:ext uri="{9D8B030D-6E8A-4147-A177-3AD203B41FA5}">
                      <a16:colId xmlns:a16="http://schemas.microsoft.com/office/drawing/2014/main" val="3554884043"/>
                    </a:ext>
                  </a:extLst>
                </a:gridCol>
                <a:gridCol w="692497">
                  <a:extLst>
                    <a:ext uri="{9D8B030D-6E8A-4147-A177-3AD203B41FA5}">
                      <a16:colId xmlns:a16="http://schemas.microsoft.com/office/drawing/2014/main" val="2668167703"/>
                    </a:ext>
                  </a:extLst>
                </a:gridCol>
                <a:gridCol w="1118561">
                  <a:extLst>
                    <a:ext uri="{9D8B030D-6E8A-4147-A177-3AD203B41FA5}">
                      <a16:colId xmlns:a16="http://schemas.microsoft.com/office/drawing/2014/main" val="4274900462"/>
                    </a:ext>
                  </a:extLst>
                </a:gridCol>
                <a:gridCol w="1120878">
                  <a:extLst>
                    <a:ext uri="{9D8B030D-6E8A-4147-A177-3AD203B41FA5}">
                      <a16:colId xmlns:a16="http://schemas.microsoft.com/office/drawing/2014/main" val="961312682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Cancer Type (N)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c-index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Adjusted HR [95% CI]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Adjusted p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MR Median rwPFS (months) [95% CI]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nMR Median rwPFS (months) [95% CI]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315582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NSCLC (185)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75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33 </a:t>
                      </a:r>
                    </a:p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0.21-0.50] </a:t>
                      </a:r>
                      <a:endParaRPr lang="en-US" b="0" i="0" dirty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&lt; 0.005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NR </a:t>
                      </a:r>
                    </a:p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9.27-NR]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4.20</a:t>
                      </a:r>
                    </a:p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3.20-5.37]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93977512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RCC (68)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75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21 </a:t>
                      </a:r>
                    </a:p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0.09-0.46]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&lt; 0.005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NR </a:t>
                      </a:r>
                    </a:p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11.63-NR]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3.30 </a:t>
                      </a:r>
                    </a:p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1.60-9.10]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80457376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MM (45)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84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11 </a:t>
                      </a:r>
                    </a:p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0.03-0.46]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03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NR </a:t>
                      </a:r>
                    </a:p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NR-NR]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3.70</a:t>
                      </a:r>
                    </a:p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0.70-8.40]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53712199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All Others (215)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73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23</a:t>
                      </a:r>
                    </a:p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0.15-0.34]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&lt; 0.005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NR </a:t>
                      </a:r>
                    </a:p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10.77-NR]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3.934 </a:t>
                      </a:r>
                    </a:p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3.067-4.467]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67732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Cancer Type (N) </a:t>
                      </a:r>
                      <a:endParaRPr lang="en-US" b="0" i="0" dirty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c-index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Adjusted HR [95% CI]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Adjusted p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MR Median rwOS (months) </a:t>
                      </a:r>
                    </a:p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95% CI]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nMR Median rwOS (months) [95% CI]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600832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NSCLC (187)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72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48 </a:t>
                      </a:r>
                    </a:p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0.30-0.78]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03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NR </a:t>
                      </a:r>
                    </a:p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NR-NR]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8.43 </a:t>
                      </a:r>
                    </a:p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5.90-12.47]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8886677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RCC (70)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87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4 </a:t>
                      </a:r>
                    </a:p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0.01-0.22]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&lt; 0.005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NR </a:t>
                      </a:r>
                    </a:p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NR-NR]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9.133</a:t>
                      </a:r>
                    </a:p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3.10-NR]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6439253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MM (46)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87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12 </a:t>
                      </a:r>
                    </a:p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0.02-0.86]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35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NR </a:t>
                      </a:r>
                    </a:p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NR-NR]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8.00</a:t>
                      </a:r>
                    </a:p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1.93-NR]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78246143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All Others (217)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73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26 </a:t>
                      </a:r>
                    </a:p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0.16-0.42]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&lt; 0.005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NR </a:t>
                      </a:r>
                    </a:p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NR-NR] </a:t>
                      </a:r>
                      <a:endParaRPr lang="en-US" b="0" i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6.47 </a:t>
                      </a:r>
                    </a:p>
                    <a:p>
                      <a:pPr algn="ctr" rtl="0" fontAlgn="base">
                        <a:lnSpc>
                          <a:spcPts val="1050"/>
                        </a:lnSpc>
                      </a:pPr>
                      <a:r>
                        <a:rPr lang="en-US" sz="900" b="0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[4.47-8.80] </a:t>
                      </a:r>
                      <a:endParaRPr lang="en-US" b="0" i="0" dirty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0878110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629D6780-8BCD-64BD-1898-B885723C8A42}"/>
              </a:ext>
            </a:extLst>
          </p:cNvPr>
          <p:cNvSpPr txBox="1"/>
          <p:nvPr/>
        </p:nvSpPr>
        <p:spPr>
          <a:xfrm>
            <a:off x="471487" y="4911194"/>
            <a:ext cx="544215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0" i="0" dirty="0">
                <a:solidFill>
                  <a:srgbClr val="000000"/>
                </a:solidFill>
                <a:effectLst/>
                <a:latin typeface="Helvetica Neue" panose="02000503000000020004" pitchFamily="2" charset="0"/>
              </a:rPr>
              <a:t>Supplementary Table S7. Longitudinal assessment of TF predicts ICI benefit in individual cancers (n=513). Table summarizing c-index, adjusted HR, adjusted p-value and median rwPFS and median rwOS for MR and nMR by cancer types </a:t>
            </a:r>
            <a:r>
              <a:rPr lang="en-US" sz="1000" b="0" i="0" dirty="0">
                <a:solidFill>
                  <a:srgbClr val="D13438"/>
                </a:solidFill>
                <a:effectLst/>
                <a:latin typeface="Helvetica Neue" panose="02000503000000020004" pitchFamily="2" charset="0"/>
              </a:rPr>
              <a:t> </a:t>
            </a:r>
            <a:endParaRPr lang="en-US" sz="10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B07AC3E-8BF2-C577-CD76-9F063633835F}"/>
              </a:ext>
            </a:extLst>
          </p:cNvPr>
          <p:cNvSpPr txBox="1"/>
          <p:nvPr/>
        </p:nvSpPr>
        <p:spPr>
          <a:xfrm>
            <a:off x="358877" y="424934"/>
            <a:ext cx="343145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0" i="0" dirty="0">
                <a:solidFill>
                  <a:srgbClr val="000000"/>
                </a:solidFill>
                <a:effectLst/>
                <a:latin typeface="Helvetica Neue" panose="02000503000000020004" pitchFamily="2" charset="0"/>
              </a:rPr>
              <a:t>Supplementary Table S7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332557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7EAB79E8A649043B57FB7E201303455" ma:contentTypeVersion="14" ma:contentTypeDescription="Create a new document." ma:contentTypeScope="" ma:versionID="e71411c950fa83840c021bf03c814f63">
  <xsd:schema xmlns:xsd="http://www.w3.org/2001/XMLSchema" xmlns:xs="http://www.w3.org/2001/XMLSchema" xmlns:p="http://schemas.microsoft.com/office/2006/metadata/properties" xmlns:ns2="b0090abd-25aa-4ac3-b924-e35af8d9ed55" xmlns:ns3="606ae6eb-d705-4ce8-b671-b906251446a9" targetNamespace="http://schemas.microsoft.com/office/2006/metadata/properties" ma:root="true" ma:fieldsID="fa0abb8aea339e328f4d0d365659916b" ns2:_="" ns3:_="">
    <xsd:import namespace="b0090abd-25aa-4ac3-b924-e35af8d9ed55"/>
    <xsd:import namespace="606ae6eb-d705-4ce8-b671-b906251446a9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LengthInSecond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0090abd-25aa-4ac3-b924-e35af8d9ed5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14" nillable="true" ma:taxonomy="true" ma:internalName="lcf76f155ced4ddcb4097134ff3c332f" ma:taxonomyFieldName="MediaServiceImageTags" ma:displayName="Image Tags" ma:readOnly="false" ma:fieldId="{5cf76f15-5ced-4ddc-b409-7134ff3c332f}" ma:taxonomyMulti="true" ma:sspId="a1d584be-b9fa-4213-aedc-5d44287790d0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  <xsd:element name="MediaServiceSearchProperties" ma:index="21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06ae6eb-d705-4ce8-b671-b906251446a9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5" nillable="true" ma:displayName="Taxonomy Catch All Column" ma:hidden="true" ma:list="{d8541e83-b154-4cb1-97f5-e6365a08337c}" ma:internalName="TaxCatchAll" ma:showField="CatchAllData" ma:web="606ae6eb-d705-4ce8-b671-b906251446a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b0090abd-25aa-4ac3-b924-e35af8d9ed55">
      <Terms xmlns="http://schemas.microsoft.com/office/infopath/2007/PartnerControls"/>
    </lcf76f155ced4ddcb4097134ff3c332f>
    <TaxCatchAll xmlns="606ae6eb-d705-4ce8-b671-b906251446a9" xsi:nil="true"/>
  </documentManagement>
</p:properties>
</file>

<file path=customXml/itemProps1.xml><?xml version="1.0" encoding="utf-8"?>
<ds:datastoreItem xmlns:ds="http://schemas.openxmlformats.org/officeDocument/2006/customXml" ds:itemID="{AF058950-C37C-4A99-A679-DB3B38A1AE72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CFDCDCFB-A19A-47C2-A857-5A1E61AC3829}">
  <ds:schemaRefs>
    <ds:schemaRef ds:uri="606ae6eb-d705-4ce8-b671-b906251446a9"/>
    <ds:schemaRef ds:uri="b0090abd-25aa-4ac3-b924-e35af8d9ed55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3.xml><?xml version="1.0" encoding="utf-8"?>
<ds:datastoreItem xmlns:ds="http://schemas.openxmlformats.org/officeDocument/2006/customXml" ds:itemID="{991CB7F9-EAA8-4639-93FB-092840FA0849}">
  <ds:schemaRefs>
    <ds:schemaRef ds:uri="b0090abd-25aa-4ac3-b924-e35af8d9ed55"/>
    <ds:schemaRef ds:uri="http://schemas.microsoft.com/office/2006/documentManagement/types"/>
    <ds:schemaRef ds:uri="http://purl.org/dc/elements/1.1/"/>
    <ds:schemaRef ds:uri="http://purl.org/dc/terms/"/>
    <ds:schemaRef ds:uri="http://schemas.microsoft.com/office/infopath/2007/PartnerControls"/>
    <ds:schemaRef ds:uri="606ae6eb-d705-4ce8-b671-b906251446a9"/>
    <ds:schemaRef ds:uri="http://schemas.microsoft.com/office/2006/metadata/properties"/>
    <ds:schemaRef ds:uri="http://schemas.openxmlformats.org/package/2006/metadata/core-properties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82</TotalTime>
  <Words>269</Words>
  <Application>Microsoft Macintosh PowerPoint</Application>
  <PresentationFormat>Letter Paper (8.5x11 in)</PresentationFormat>
  <Paragraphs>8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Helvetica Neu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ra Wienke</dc:creator>
  <cp:lastModifiedBy>Samantha Liang</cp:lastModifiedBy>
  <cp:revision>15</cp:revision>
  <dcterms:created xsi:type="dcterms:W3CDTF">2024-12-13T18:22:33Z</dcterms:created>
  <dcterms:modified xsi:type="dcterms:W3CDTF">2025-07-09T17:12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7EAB79E8A649043B57FB7E201303455</vt:lpwstr>
  </property>
  <property fmtid="{D5CDD505-2E9C-101B-9397-08002B2CF9AE}" pid="3" name="MediaServiceImageTags">
    <vt:lpwstr/>
  </property>
</Properties>
</file>